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1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4" autoAdjust="0"/>
    <p:restoredTop sz="94660"/>
  </p:normalViewPr>
  <p:slideViewPr>
    <p:cSldViewPr snapToGrid="0">
      <p:cViewPr varScale="1">
        <p:scale>
          <a:sx n="128" d="100"/>
          <a:sy n="128" d="100"/>
        </p:scale>
        <p:origin x="52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6841A7-D4F0-B474-F9EF-C5E7946A681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60E9CD1-07DB-7E8D-DEAB-EF4D8C5B042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7ECAB9-8C26-B6BE-4832-40751192D6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F38EEF-71A4-4D51-9230-07AE6D8541D5}" type="datetimeFigureOut">
              <a:rPr lang="en-US" smtClean="0"/>
              <a:t>1/5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CF3232-E142-090E-EE68-C9037B1704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60EBF4-DC54-6233-0436-0D1B0CB0AC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CFEFD-E469-4FF5-BE63-F43AAB111A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21300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C67E09-1E09-1B13-D67D-F0B3B8681A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D8E1405-04BB-E1FA-BAC1-91375B2203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549D89-2764-22DF-D5AE-C312C24861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F38EEF-71A4-4D51-9230-07AE6D8541D5}" type="datetimeFigureOut">
              <a:rPr lang="en-US" smtClean="0"/>
              <a:t>1/5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E9B775-DDD2-9F15-3C0A-2FAE46AC5E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A5E908-CB52-F59D-2E8D-55F3A3E011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CFEFD-E469-4FF5-BE63-F43AAB111A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6355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2A93AEF-308D-2158-302B-8E7603414E3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54FE69C-27A3-C4B8-7535-A2D20C0C58A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AB9209-B9D0-6A28-365B-2377461F69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F38EEF-71A4-4D51-9230-07AE6D8541D5}" type="datetimeFigureOut">
              <a:rPr lang="en-US" smtClean="0"/>
              <a:t>1/5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D9AFEB-1CC3-5D80-C4B7-5110E57B17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CC5080-1478-F80D-4943-A8D06BD557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CFEFD-E469-4FF5-BE63-F43AAB111A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46754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B6F7E1-0A3D-4320-9CA5-FB43E94FF6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2079147-44AE-A4AB-605E-4BD5F6F849C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B72203-DD20-8611-67E9-12E7E46794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F38EEF-71A4-4D51-9230-07AE6D8541D5}" type="datetimeFigureOut">
              <a:rPr lang="en-US" smtClean="0"/>
              <a:t>1/5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9B5C49-7437-2428-A788-F0B79836B3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9B59D3-C515-EBA0-9DDC-F30BFFBF93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CFEFD-E469-4FF5-BE63-F43AAB111A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15093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B40741-AB6C-2479-DA31-6BD7C16926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FC503BD-FE43-F1A5-4955-FC365D80A2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FF51B3-08E6-A93A-A1CD-D29CA49260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F38EEF-71A4-4D51-9230-07AE6D8541D5}" type="datetimeFigureOut">
              <a:rPr lang="en-US" smtClean="0"/>
              <a:t>1/5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2C8930-3F2C-D397-13B3-76F9529454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6349D3-60E5-9111-D6CB-339048CCD3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CFEFD-E469-4FF5-BE63-F43AAB111A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49579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099868-D1EE-1B63-8D33-5EFA2EA338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CF90DF3-5C2C-4B2D-AB51-DE4897A94F0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4F8EB57-4214-D83E-EEF8-0D3C3B3889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6A8EB06-789C-71C2-410A-06EEDE9D97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F38EEF-71A4-4D51-9230-07AE6D8541D5}" type="datetimeFigureOut">
              <a:rPr lang="en-US" smtClean="0"/>
              <a:t>1/5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DA7D3D7-0B18-B141-1CC4-661EC027BF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B8845C5-1315-1E2A-5EE9-F17D5DBB2B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CFEFD-E469-4FF5-BE63-F43AAB111A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45325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9EAD2E-E409-8BED-7291-E329196E4D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6DC663E-2C89-86BF-116C-159DB331C4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FB4DD93-A82E-5F15-4971-A029E27A85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E7E3963-3C5E-4BE9-7EF5-5CB6A053375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5491B3C-871D-2164-4CDD-6EEE496BE12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C93B748-BE37-43DC-1E22-21F714FB6B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F38EEF-71A4-4D51-9230-07AE6D8541D5}" type="datetimeFigureOut">
              <a:rPr lang="en-US" smtClean="0"/>
              <a:t>1/5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FD0745C-C291-B017-E919-68EB5622A0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5F85533-9006-E19F-56F9-CDCE21CBC5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CFEFD-E469-4FF5-BE63-F43AAB111A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72702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122C57-3173-2B71-956E-FE2406469A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95426F7-6032-7388-A995-40049C9205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F38EEF-71A4-4D51-9230-07AE6D8541D5}" type="datetimeFigureOut">
              <a:rPr lang="en-US" smtClean="0"/>
              <a:t>1/5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71E00F3-609B-617A-0A37-B3D1F85738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3DAA36F-9A98-0414-6851-44DD367A3C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CFEFD-E469-4FF5-BE63-F43AAB111A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5336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628068B-D734-71BD-BF46-92EE613E3D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F38EEF-71A4-4D51-9230-07AE6D8541D5}" type="datetimeFigureOut">
              <a:rPr lang="en-US" smtClean="0"/>
              <a:t>1/5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4FCB505-FA0B-363C-CCBD-784CD2B2EE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146DA7E-B484-200D-1499-9F1A8C19AA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CFEFD-E469-4FF5-BE63-F43AAB111A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94375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AC0062-2F4E-7A4B-64A4-6B92B82B5C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B330E6E-4CBE-70F4-24C7-2B42FEC714A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5892E2E-0432-154D-7BCD-D962200D459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E4B0D30-0E71-F5D0-05DF-B8A9A20AAD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F38EEF-71A4-4D51-9230-07AE6D8541D5}" type="datetimeFigureOut">
              <a:rPr lang="en-US" smtClean="0"/>
              <a:t>1/5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789E786-1485-FE0C-263E-E7CC2046DF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542CA76-A2C0-06EC-D437-5342E8983F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CFEFD-E469-4FF5-BE63-F43AAB111A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65324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D78BF4-938F-6A7A-39E3-2D1C10BD15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85F70B2-93D7-1F0A-2A3D-CE768B5C07F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C361663-BEEB-F880-2A39-78467BCF83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7DB7DF-04AC-71DA-1956-D37C592850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F38EEF-71A4-4D51-9230-07AE6D8541D5}" type="datetimeFigureOut">
              <a:rPr lang="en-US" smtClean="0"/>
              <a:t>1/5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A97FEDE-5BE6-90C6-FABE-145F3D48AD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C95547E-B301-0925-2212-EAF89C3FE8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CFEFD-E469-4FF5-BE63-F43AAB111A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28134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358A3D1-22DF-1830-A70E-EE03CEB402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D3D5EAB-2E14-A69F-BFAE-C48A353188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60C4D7-4CAB-CCA3-D23D-101B6F273DE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F38EEF-71A4-4D51-9230-07AE6D8541D5}" type="datetimeFigureOut">
              <a:rPr lang="en-US" smtClean="0"/>
              <a:t>1/5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CAEF3B-99B8-5530-F28C-78231DBF114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E317D4-5182-97E0-3498-FB6592B2C41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4CFEFD-E469-4FF5-BE63-F43AAB111A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28281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BAA835AC-B6B4-C826-EC3B-275E856BAF9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46848" y="1938537"/>
            <a:ext cx="4572000" cy="120967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2A45D3FC-874C-72C9-E12F-4DAF48114B9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72341" y="1843287"/>
            <a:ext cx="4886325" cy="1304925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372E884E-A5A1-3253-8CBC-595585D64305}"/>
              </a:ext>
            </a:extLst>
          </p:cNvPr>
          <p:cNvSpPr txBox="1"/>
          <p:nvPr/>
        </p:nvSpPr>
        <p:spPr>
          <a:xfrm>
            <a:off x="152971" y="2358708"/>
            <a:ext cx="7927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 err="1"/>
              <a:t>pEGFR</a:t>
            </a:r>
            <a:endParaRPr lang="en-US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45C15E2-1B5E-C5E8-C724-D16E178E6BB8}"/>
              </a:ext>
            </a:extLst>
          </p:cNvPr>
          <p:cNvSpPr txBox="1"/>
          <p:nvPr/>
        </p:nvSpPr>
        <p:spPr>
          <a:xfrm>
            <a:off x="6002265" y="2311083"/>
            <a:ext cx="6708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GFR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2F5DCFD0-8365-1314-4394-F06F20D27DF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772341" y="3230420"/>
            <a:ext cx="4886325" cy="1276350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115091DB-5931-FE93-A838-D9AAD045FE0B}"/>
              </a:ext>
            </a:extLst>
          </p:cNvPr>
          <p:cNvSpPr txBox="1"/>
          <p:nvPr/>
        </p:nvSpPr>
        <p:spPr>
          <a:xfrm>
            <a:off x="6175211" y="3429000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K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9736E2A-9818-8E6B-8181-28541C9EAD7B}"/>
              </a:ext>
            </a:extLst>
          </p:cNvPr>
          <p:cNvSpPr txBox="1"/>
          <p:nvPr/>
        </p:nvSpPr>
        <p:spPr>
          <a:xfrm>
            <a:off x="281725" y="3876489"/>
            <a:ext cx="6639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 err="1"/>
              <a:t>pERK</a:t>
            </a:r>
            <a:endParaRPr lang="en-US" dirty="0"/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E61F72D3-AEA0-6EF7-9E46-80B4271321C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45690" y="3268520"/>
            <a:ext cx="4572000" cy="1200150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56126187-F3E2-4AE5-DDF1-C70699617240}"/>
              </a:ext>
            </a:extLst>
          </p:cNvPr>
          <p:cNvSpPr txBox="1"/>
          <p:nvPr/>
        </p:nvSpPr>
        <p:spPr>
          <a:xfrm>
            <a:off x="-23191" y="3525123"/>
            <a:ext cx="968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 err="1"/>
              <a:t>pAKT</a:t>
            </a:r>
            <a:endParaRPr lang="en-US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478A4C6-6413-C0D9-B258-EAD3903D6316}"/>
              </a:ext>
            </a:extLst>
          </p:cNvPr>
          <p:cNvSpPr txBox="1"/>
          <p:nvPr/>
        </p:nvSpPr>
        <p:spPr>
          <a:xfrm>
            <a:off x="6175211" y="3744228"/>
            <a:ext cx="5431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RK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ABB373EE-B0A0-1B81-82E3-560E58A9B8A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772341" y="4588978"/>
            <a:ext cx="4886325" cy="723900"/>
          </a:xfrm>
          <a:prstGeom prst="rect">
            <a:avLst/>
          </a:prstGeom>
        </p:spPr>
      </p:pic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D6E74D1E-8927-07E9-95D7-153BE5D82640}"/>
              </a:ext>
            </a:extLst>
          </p:cNvPr>
          <p:cNvCxnSpPr/>
          <p:nvPr/>
        </p:nvCxnSpPr>
        <p:spPr>
          <a:xfrm>
            <a:off x="1678872" y="560666"/>
            <a:ext cx="166163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35A6F97E-C24A-15E5-9F99-181B6584CBF5}"/>
              </a:ext>
            </a:extLst>
          </p:cNvPr>
          <p:cNvCxnSpPr/>
          <p:nvPr/>
        </p:nvCxnSpPr>
        <p:spPr>
          <a:xfrm>
            <a:off x="3505588" y="560666"/>
            <a:ext cx="166163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64B51922-F188-3186-B24C-FCE861F420B2}"/>
              </a:ext>
            </a:extLst>
          </p:cNvPr>
          <p:cNvSpPr txBox="1"/>
          <p:nvPr/>
        </p:nvSpPr>
        <p:spPr>
          <a:xfrm>
            <a:off x="1879512" y="158476"/>
            <a:ext cx="13457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GFR-ERBB4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BD56E4E-F4E3-FF7F-132F-34F76DFE3CAC}"/>
              </a:ext>
            </a:extLst>
          </p:cNvPr>
          <p:cNvSpPr txBox="1"/>
          <p:nvPr/>
        </p:nvSpPr>
        <p:spPr>
          <a:xfrm>
            <a:off x="3684543" y="158476"/>
            <a:ext cx="1231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GFR-SHC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3837466-04A0-D09B-D5BE-AFD5A1C75F4A}"/>
              </a:ext>
            </a:extLst>
          </p:cNvPr>
          <p:cNvSpPr txBox="1"/>
          <p:nvPr/>
        </p:nvSpPr>
        <p:spPr>
          <a:xfrm rot="16200000">
            <a:off x="1395072" y="1517685"/>
            <a:ext cx="626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DMSO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6654AE1-08BB-B48D-5F52-A66C4B07FD26}"/>
              </a:ext>
            </a:extLst>
          </p:cNvPr>
          <p:cNvSpPr txBox="1"/>
          <p:nvPr/>
        </p:nvSpPr>
        <p:spPr>
          <a:xfrm rot="16200000">
            <a:off x="1731254" y="1517685"/>
            <a:ext cx="626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DMSO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8C0148B-0AAA-1ABC-D67B-A810EAE5F704}"/>
              </a:ext>
            </a:extLst>
          </p:cNvPr>
          <p:cNvSpPr txBox="1"/>
          <p:nvPr/>
        </p:nvSpPr>
        <p:spPr>
          <a:xfrm rot="16200000">
            <a:off x="2056020" y="1497960"/>
            <a:ext cx="6661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gefitnib</a:t>
            </a:r>
            <a:endParaRPr lang="en-US" sz="12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33F3717-1944-51AC-DF5A-14DD8AF5E526}"/>
              </a:ext>
            </a:extLst>
          </p:cNvPr>
          <p:cNvSpPr txBox="1"/>
          <p:nvPr/>
        </p:nvSpPr>
        <p:spPr>
          <a:xfrm rot="16200000">
            <a:off x="2318396" y="1501229"/>
            <a:ext cx="6595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afatinib</a:t>
            </a:r>
            <a:endParaRPr lang="en-US" sz="12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4C7F7B6-A4A1-E50D-08BF-B300997AC031}"/>
              </a:ext>
            </a:extLst>
          </p:cNvPr>
          <p:cNvSpPr txBox="1"/>
          <p:nvPr/>
        </p:nvSpPr>
        <p:spPr>
          <a:xfrm rot="16200000">
            <a:off x="2450342" y="1362050"/>
            <a:ext cx="9379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osimertinib</a:t>
            </a:r>
            <a:endParaRPr lang="en-US" sz="12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A605367-28AD-45F1-ABAC-E64D69975150}"/>
              </a:ext>
            </a:extLst>
          </p:cNvPr>
          <p:cNvSpPr txBox="1"/>
          <p:nvPr/>
        </p:nvSpPr>
        <p:spPr>
          <a:xfrm rot="16200000">
            <a:off x="2763876" y="1362050"/>
            <a:ext cx="9379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tarloxotinib</a:t>
            </a:r>
            <a:endParaRPr lang="en-US" sz="12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D788B83-892F-A38A-08CB-4BA61887074E}"/>
              </a:ext>
            </a:extLst>
          </p:cNvPr>
          <p:cNvSpPr txBox="1"/>
          <p:nvPr/>
        </p:nvSpPr>
        <p:spPr>
          <a:xfrm rot="16200000">
            <a:off x="3203895" y="1534970"/>
            <a:ext cx="626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DMSO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CC1FCD8-2FA3-692B-E070-112618F0F93E}"/>
              </a:ext>
            </a:extLst>
          </p:cNvPr>
          <p:cNvSpPr txBox="1"/>
          <p:nvPr/>
        </p:nvSpPr>
        <p:spPr>
          <a:xfrm rot="16200000">
            <a:off x="3540077" y="1534970"/>
            <a:ext cx="626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DMSO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1284172-85C5-DBAD-FF78-0212435B1A97}"/>
              </a:ext>
            </a:extLst>
          </p:cNvPr>
          <p:cNvSpPr txBox="1"/>
          <p:nvPr/>
        </p:nvSpPr>
        <p:spPr>
          <a:xfrm rot="16200000">
            <a:off x="3864843" y="1515245"/>
            <a:ext cx="6661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gefitnib</a:t>
            </a:r>
            <a:endParaRPr lang="en-US" sz="12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BC397FA-B487-8531-0348-1A0EB16F61A0}"/>
              </a:ext>
            </a:extLst>
          </p:cNvPr>
          <p:cNvSpPr txBox="1"/>
          <p:nvPr/>
        </p:nvSpPr>
        <p:spPr>
          <a:xfrm rot="16200000">
            <a:off x="4127219" y="1518514"/>
            <a:ext cx="6595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afatinib</a:t>
            </a:r>
            <a:endParaRPr lang="en-US" sz="12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30434C7-81A6-43CF-7401-02881E2173ED}"/>
              </a:ext>
            </a:extLst>
          </p:cNvPr>
          <p:cNvSpPr txBox="1"/>
          <p:nvPr/>
        </p:nvSpPr>
        <p:spPr>
          <a:xfrm rot="16200000">
            <a:off x="4259165" y="1379335"/>
            <a:ext cx="9379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osimertinib</a:t>
            </a:r>
            <a:endParaRPr lang="en-US" sz="12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E00DB71E-1E3B-09E1-3549-860569A56187}"/>
              </a:ext>
            </a:extLst>
          </p:cNvPr>
          <p:cNvSpPr txBox="1"/>
          <p:nvPr/>
        </p:nvSpPr>
        <p:spPr>
          <a:xfrm rot="16200000">
            <a:off x="4572699" y="1379335"/>
            <a:ext cx="9379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tarloxotinib</a:t>
            </a:r>
            <a:endParaRPr lang="en-US" sz="12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77334D80-7B4F-40CF-BB62-213E2B14910B}"/>
              </a:ext>
            </a:extLst>
          </p:cNvPr>
          <p:cNvSpPr txBox="1"/>
          <p:nvPr/>
        </p:nvSpPr>
        <p:spPr>
          <a:xfrm>
            <a:off x="2067812" y="830163"/>
            <a:ext cx="12460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00nM </a:t>
            </a:r>
            <a:r>
              <a:rPr lang="en-US" sz="1200" dirty="0" err="1"/>
              <a:t>alectinib</a:t>
            </a:r>
            <a:endParaRPr lang="en-US" sz="1200" dirty="0"/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002ED252-8C2D-D0C5-5FFD-401D8E93111C}"/>
              </a:ext>
            </a:extLst>
          </p:cNvPr>
          <p:cNvCxnSpPr/>
          <p:nvPr/>
        </p:nvCxnSpPr>
        <p:spPr>
          <a:xfrm>
            <a:off x="2044591" y="1086750"/>
            <a:ext cx="129591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5C82AE51-ADEE-5F1B-503A-89EE41A18328}"/>
              </a:ext>
            </a:extLst>
          </p:cNvPr>
          <p:cNvSpPr txBox="1"/>
          <p:nvPr/>
        </p:nvSpPr>
        <p:spPr>
          <a:xfrm>
            <a:off x="3836953" y="858817"/>
            <a:ext cx="12460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00nM </a:t>
            </a:r>
            <a:r>
              <a:rPr lang="en-US" sz="1200" dirty="0" err="1"/>
              <a:t>alectinib</a:t>
            </a:r>
            <a:endParaRPr lang="en-US" sz="1200" dirty="0"/>
          </a:p>
        </p:txBody>
      </p: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92A0E672-D0B1-301B-234B-719B2CEFADE2}"/>
              </a:ext>
            </a:extLst>
          </p:cNvPr>
          <p:cNvCxnSpPr/>
          <p:nvPr/>
        </p:nvCxnSpPr>
        <p:spPr>
          <a:xfrm>
            <a:off x="3813732" y="1115404"/>
            <a:ext cx="129591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62069AD0-7D7A-BF6B-4391-B19D303CF2F7}"/>
              </a:ext>
            </a:extLst>
          </p:cNvPr>
          <p:cNvCxnSpPr/>
          <p:nvPr/>
        </p:nvCxnSpPr>
        <p:spPr>
          <a:xfrm>
            <a:off x="7525768" y="436051"/>
            <a:ext cx="166163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9C66BDCA-7502-B237-6F0C-E72603A0486D}"/>
              </a:ext>
            </a:extLst>
          </p:cNvPr>
          <p:cNvCxnSpPr/>
          <p:nvPr/>
        </p:nvCxnSpPr>
        <p:spPr>
          <a:xfrm>
            <a:off x="9352484" y="436051"/>
            <a:ext cx="166163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A54AB8E5-6939-7B42-7653-65D3A14B32B8}"/>
              </a:ext>
            </a:extLst>
          </p:cNvPr>
          <p:cNvSpPr txBox="1"/>
          <p:nvPr/>
        </p:nvSpPr>
        <p:spPr>
          <a:xfrm>
            <a:off x="7726408" y="33861"/>
            <a:ext cx="13457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GFR-ERBB4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F300EA57-3841-5EEA-6471-787928BB3C89}"/>
              </a:ext>
            </a:extLst>
          </p:cNvPr>
          <p:cNvSpPr txBox="1"/>
          <p:nvPr/>
        </p:nvSpPr>
        <p:spPr>
          <a:xfrm>
            <a:off x="9531439" y="33861"/>
            <a:ext cx="1231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GFR-SHC1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3D292BD5-3C11-1905-CBAC-6ACFBEB4B92D}"/>
              </a:ext>
            </a:extLst>
          </p:cNvPr>
          <p:cNvSpPr txBox="1"/>
          <p:nvPr/>
        </p:nvSpPr>
        <p:spPr>
          <a:xfrm rot="16200000">
            <a:off x="7241968" y="1393070"/>
            <a:ext cx="626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DMSO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44B7FBD7-C040-DE42-96FE-BF2A92EAD8F3}"/>
              </a:ext>
            </a:extLst>
          </p:cNvPr>
          <p:cNvSpPr txBox="1"/>
          <p:nvPr/>
        </p:nvSpPr>
        <p:spPr>
          <a:xfrm rot="16200000">
            <a:off x="7578150" y="1393070"/>
            <a:ext cx="626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DMSO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39BB9867-F435-4A9B-4D0A-C5D2E2A86276}"/>
              </a:ext>
            </a:extLst>
          </p:cNvPr>
          <p:cNvSpPr txBox="1"/>
          <p:nvPr/>
        </p:nvSpPr>
        <p:spPr>
          <a:xfrm rot="16200000">
            <a:off x="7902916" y="1373345"/>
            <a:ext cx="6661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gefitnib</a:t>
            </a:r>
            <a:endParaRPr lang="en-US" sz="1200" dirty="0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BE79AB9C-CC63-0EAE-74F9-50F005AB9CA7}"/>
              </a:ext>
            </a:extLst>
          </p:cNvPr>
          <p:cNvSpPr txBox="1"/>
          <p:nvPr/>
        </p:nvSpPr>
        <p:spPr>
          <a:xfrm rot="16200000">
            <a:off x="8165292" y="1376614"/>
            <a:ext cx="6595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afatinib</a:t>
            </a:r>
            <a:endParaRPr lang="en-US" sz="1200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8132B303-D311-912D-5C3A-E43D058A3DD7}"/>
              </a:ext>
            </a:extLst>
          </p:cNvPr>
          <p:cNvSpPr txBox="1"/>
          <p:nvPr/>
        </p:nvSpPr>
        <p:spPr>
          <a:xfrm rot="16200000">
            <a:off x="8297238" y="1237435"/>
            <a:ext cx="9379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osimertinib</a:t>
            </a:r>
            <a:endParaRPr lang="en-US" sz="1200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A6B6AED9-E83E-8914-9E1C-3B7FA3669FBC}"/>
              </a:ext>
            </a:extLst>
          </p:cNvPr>
          <p:cNvSpPr txBox="1"/>
          <p:nvPr/>
        </p:nvSpPr>
        <p:spPr>
          <a:xfrm rot="16200000">
            <a:off x="8610772" y="1237435"/>
            <a:ext cx="9379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tarloxotinib</a:t>
            </a:r>
            <a:endParaRPr lang="en-US" sz="1200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B7BC3BE0-E8D8-CA87-9FCE-45BDBAB110CD}"/>
              </a:ext>
            </a:extLst>
          </p:cNvPr>
          <p:cNvSpPr txBox="1"/>
          <p:nvPr/>
        </p:nvSpPr>
        <p:spPr>
          <a:xfrm rot="16200000">
            <a:off x="9050791" y="1410355"/>
            <a:ext cx="626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DMSO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6BCE7432-7A3A-CC6E-3C95-070514E1D878}"/>
              </a:ext>
            </a:extLst>
          </p:cNvPr>
          <p:cNvSpPr txBox="1"/>
          <p:nvPr/>
        </p:nvSpPr>
        <p:spPr>
          <a:xfrm rot="16200000">
            <a:off x="9386973" y="1410355"/>
            <a:ext cx="626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DMSO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931A7E87-273F-D853-2019-9599D816394E}"/>
              </a:ext>
            </a:extLst>
          </p:cNvPr>
          <p:cNvSpPr txBox="1"/>
          <p:nvPr/>
        </p:nvSpPr>
        <p:spPr>
          <a:xfrm rot="16200000">
            <a:off x="9711739" y="1390630"/>
            <a:ext cx="6661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gefitnib</a:t>
            </a:r>
            <a:endParaRPr lang="en-US" sz="1200" dirty="0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E425136C-9955-B34D-31B9-B1AD14A2798A}"/>
              </a:ext>
            </a:extLst>
          </p:cNvPr>
          <p:cNvSpPr txBox="1"/>
          <p:nvPr/>
        </p:nvSpPr>
        <p:spPr>
          <a:xfrm rot="16200000">
            <a:off x="9974115" y="1393899"/>
            <a:ext cx="6595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afatinib</a:t>
            </a:r>
            <a:endParaRPr lang="en-US" sz="1200" dirty="0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34E6044A-847C-3371-1845-33C7E111412E}"/>
              </a:ext>
            </a:extLst>
          </p:cNvPr>
          <p:cNvSpPr txBox="1"/>
          <p:nvPr/>
        </p:nvSpPr>
        <p:spPr>
          <a:xfrm rot="16200000">
            <a:off x="10106061" y="1254720"/>
            <a:ext cx="9379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osimertinib</a:t>
            </a:r>
            <a:endParaRPr lang="en-US" sz="1200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A505C432-5D05-C6AF-07B6-653B3F602DAE}"/>
              </a:ext>
            </a:extLst>
          </p:cNvPr>
          <p:cNvSpPr txBox="1"/>
          <p:nvPr/>
        </p:nvSpPr>
        <p:spPr>
          <a:xfrm rot="16200000">
            <a:off x="10419595" y="1254720"/>
            <a:ext cx="9379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tarloxotinib</a:t>
            </a:r>
            <a:endParaRPr lang="en-US" sz="1200" dirty="0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9A38220D-19A2-E9BF-7263-2C47D06E0BF6}"/>
              </a:ext>
            </a:extLst>
          </p:cNvPr>
          <p:cNvSpPr txBox="1"/>
          <p:nvPr/>
        </p:nvSpPr>
        <p:spPr>
          <a:xfrm>
            <a:off x="7914708" y="705548"/>
            <a:ext cx="12460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00nM </a:t>
            </a:r>
            <a:r>
              <a:rPr lang="en-US" sz="1200" dirty="0" err="1"/>
              <a:t>alectinib</a:t>
            </a:r>
            <a:endParaRPr lang="en-US" sz="1200" dirty="0"/>
          </a:p>
        </p:txBody>
      </p: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394AAE72-10BE-E1E5-ED0D-30E8C461F579}"/>
              </a:ext>
            </a:extLst>
          </p:cNvPr>
          <p:cNvCxnSpPr/>
          <p:nvPr/>
        </p:nvCxnSpPr>
        <p:spPr>
          <a:xfrm>
            <a:off x="7891487" y="962135"/>
            <a:ext cx="129591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66">
            <a:extLst>
              <a:ext uri="{FF2B5EF4-FFF2-40B4-BE49-F238E27FC236}">
                <a16:creationId xmlns:a16="http://schemas.microsoft.com/office/drawing/2014/main" id="{5EFA2D4A-09F8-F1B0-A4BD-3ECEC0A70042}"/>
              </a:ext>
            </a:extLst>
          </p:cNvPr>
          <p:cNvSpPr txBox="1"/>
          <p:nvPr/>
        </p:nvSpPr>
        <p:spPr>
          <a:xfrm>
            <a:off x="9683849" y="734202"/>
            <a:ext cx="12460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00nM </a:t>
            </a:r>
            <a:r>
              <a:rPr lang="en-US" sz="1200" dirty="0" err="1"/>
              <a:t>alectinib</a:t>
            </a:r>
            <a:endParaRPr lang="en-US" sz="1200" dirty="0"/>
          </a:p>
        </p:txBody>
      </p: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A54D0153-AD72-2850-A22A-981DEBBB6484}"/>
              </a:ext>
            </a:extLst>
          </p:cNvPr>
          <p:cNvCxnSpPr/>
          <p:nvPr/>
        </p:nvCxnSpPr>
        <p:spPr>
          <a:xfrm>
            <a:off x="9660628" y="990789"/>
            <a:ext cx="129591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68">
            <a:extLst>
              <a:ext uri="{FF2B5EF4-FFF2-40B4-BE49-F238E27FC236}">
                <a16:creationId xmlns:a16="http://schemas.microsoft.com/office/drawing/2014/main" id="{6A3A8123-05CE-3B5C-DF8A-C1A45EBB7545}"/>
              </a:ext>
            </a:extLst>
          </p:cNvPr>
          <p:cNvSpPr txBox="1"/>
          <p:nvPr/>
        </p:nvSpPr>
        <p:spPr>
          <a:xfrm>
            <a:off x="5830349" y="4692764"/>
            <a:ext cx="864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APDH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8D341F1-8A62-3CDC-5C48-888D183FBE7B}"/>
              </a:ext>
            </a:extLst>
          </p:cNvPr>
          <p:cNvSpPr txBox="1"/>
          <p:nvPr/>
        </p:nvSpPr>
        <p:spPr>
          <a:xfrm>
            <a:off x="1763535" y="6297334"/>
            <a:ext cx="1330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00 channel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57A9393-F065-A80F-CABE-2252B29E56FD}"/>
              </a:ext>
            </a:extLst>
          </p:cNvPr>
          <p:cNvSpPr txBox="1"/>
          <p:nvPr/>
        </p:nvSpPr>
        <p:spPr>
          <a:xfrm>
            <a:off x="8811892" y="6297334"/>
            <a:ext cx="1330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00 channel</a:t>
            </a:r>
          </a:p>
        </p:txBody>
      </p:sp>
    </p:spTree>
    <p:extLst>
      <p:ext uri="{BB962C8B-B14F-4D97-AF65-F5344CB8AC3E}">
        <p14:creationId xmlns:p14="http://schemas.microsoft.com/office/powerpoint/2010/main" val="39956730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372E884E-A5A1-3253-8CBC-595585D64305}"/>
              </a:ext>
            </a:extLst>
          </p:cNvPr>
          <p:cNvSpPr txBox="1"/>
          <p:nvPr/>
        </p:nvSpPr>
        <p:spPr>
          <a:xfrm>
            <a:off x="148494" y="2510909"/>
            <a:ext cx="8126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/>
              <a:t>pHER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45C15E2-1B5E-C5E8-C724-D16E178E6BB8}"/>
              </a:ext>
            </a:extLst>
          </p:cNvPr>
          <p:cNvSpPr txBox="1"/>
          <p:nvPr/>
        </p:nvSpPr>
        <p:spPr>
          <a:xfrm>
            <a:off x="6002265" y="2311083"/>
            <a:ext cx="6708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GFR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15091DB-5931-FE93-A838-D9AAD045FE0B}"/>
              </a:ext>
            </a:extLst>
          </p:cNvPr>
          <p:cNvSpPr txBox="1"/>
          <p:nvPr/>
        </p:nvSpPr>
        <p:spPr>
          <a:xfrm>
            <a:off x="6191146" y="3808254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K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9736E2A-9818-8E6B-8181-28541C9EAD7B}"/>
              </a:ext>
            </a:extLst>
          </p:cNvPr>
          <p:cNvSpPr txBox="1"/>
          <p:nvPr/>
        </p:nvSpPr>
        <p:spPr>
          <a:xfrm>
            <a:off x="297171" y="4113560"/>
            <a:ext cx="6639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 err="1"/>
              <a:t>pERK</a:t>
            </a:r>
            <a:endParaRPr lang="en-US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6126187-F3E2-4AE5-DDF1-C70699617240}"/>
              </a:ext>
            </a:extLst>
          </p:cNvPr>
          <p:cNvSpPr txBox="1"/>
          <p:nvPr/>
        </p:nvSpPr>
        <p:spPr>
          <a:xfrm>
            <a:off x="-34964" y="3793094"/>
            <a:ext cx="968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 err="1"/>
              <a:t>pAKT</a:t>
            </a:r>
            <a:endParaRPr lang="en-US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478A4C6-6413-C0D9-B258-EAD3903D6316}"/>
              </a:ext>
            </a:extLst>
          </p:cNvPr>
          <p:cNvSpPr txBox="1"/>
          <p:nvPr/>
        </p:nvSpPr>
        <p:spPr>
          <a:xfrm>
            <a:off x="6129971" y="4298226"/>
            <a:ext cx="5431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RK</a:t>
            </a:r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D6E74D1E-8927-07E9-95D7-153BE5D82640}"/>
              </a:ext>
            </a:extLst>
          </p:cNvPr>
          <p:cNvCxnSpPr/>
          <p:nvPr/>
        </p:nvCxnSpPr>
        <p:spPr>
          <a:xfrm>
            <a:off x="1678872" y="560666"/>
            <a:ext cx="166163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35A6F97E-C24A-15E5-9F99-181B6584CBF5}"/>
              </a:ext>
            </a:extLst>
          </p:cNvPr>
          <p:cNvCxnSpPr/>
          <p:nvPr/>
        </p:nvCxnSpPr>
        <p:spPr>
          <a:xfrm>
            <a:off x="3505588" y="560666"/>
            <a:ext cx="166163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64B51922-F188-3186-B24C-FCE861F420B2}"/>
              </a:ext>
            </a:extLst>
          </p:cNvPr>
          <p:cNvSpPr txBox="1"/>
          <p:nvPr/>
        </p:nvSpPr>
        <p:spPr>
          <a:xfrm>
            <a:off x="1448615" y="172057"/>
            <a:ext cx="20569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RBB2-GRB7 (short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BD56E4E-F4E3-FF7F-132F-34F76DFE3CAC}"/>
              </a:ext>
            </a:extLst>
          </p:cNvPr>
          <p:cNvSpPr txBox="1"/>
          <p:nvPr/>
        </p:nvSpPr>
        <p:spPr>
          <a:xfrm>
            <a:off x="3684543" y="172057"/>
            <a:ext cx="18469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RBB2-GR7 (long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3837466-04A0-D09B-D5BE-AFD5A1C75F4A}"/>
              </a:ext>
            </a:extLst>
          </p:cNvPr>
          <p:cNvSpPr txBox="1"/>
          <p:nvPr/>
        </p:nvSpPr>
        <p:spPr>
          <a:xfrm rot="16200000">
            <a:off x="1395072" y="1517685"/>
            <a:ext cx="626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DMSO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6654AE1-08BB-B48D-5F52-A66C4B07FD26}"/>
              </a:ext>
            </a:extLst>
          </p:cNvPr>
          <p:cNvSpPr txBox="1"/>
          <p:nvPr/>
        </p:nvSpPr>
        <p:spPr>
          <a:xfrm rot="16200000">
            <a:off x="1731254" y="1517685"/>
            <a:ext cx="626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DMSO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8C0148B-0AAA-1ABC-D67B-A810EAE5F704}"/>
              </a:ext>
            </a:extLst>
          </p:cNvPr>
          <p:cNvSpPr txBox="1"/>
          <p:nvPr/>
        </p:nvSpPr>
        <p:spPr>
          <a:xfrm rot="16200000">
            <a:off x="2056020" y="1497960"/>
            <a:ext cx="6661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gefitnib</a:t>
            </a:r>
            <a:endParaRPr lang="en-US" sz="12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33F3717-1944-51AC-DF5A-14DD8AF5E526}"/>
              </a:ext>
            </a:extLst>
          </p:cNvPr>
          <p:cNvSpPr txBox="1"/>
          <p:nvPr/>
        </p:nvSpPr>
        <p:spPr>
          <a:xfrm rot="16200000">
            <a:off x="2318396" y="1501229"/>
            <a:ext cx="6595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afatinib</a:t>
            </a:r>
            <a:endParaRPr lang="en-US" sz="12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4C7F7B6-A4A1-E50D-08BF-B300997AC031}"/>
              </a:ext>
            </a:extLst>
          </p:cNvPr>
          <p:cNvSpPr txBox="1"/>
          <p:nvPr/>
        </p:nvSpPr>
        <p:spPr>
          <a:xfrm rot="16200000">
            <a:off x="2450342" y="1362050"/>
            <a:ext cx="9379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osimertinib</a:t>
            </a:r>
            <a:endParaRPr lang="en-US" sz="12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A605367-28AD-45F1-ABAC-E64D69975150}"/>
              </a:ext>
            </a:extLst>
          </p:cNvPr>
          <p:cNvSpPr txBox="1"/>
          <p:nvPr/>
        </p:nvSpPr>
        <p:spPr>
          <a:xfrm rot="16200000">
            <a:off x="2763876" y="1362050"/>
            <a:ext cx="9379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tarloxotinib</a:t>
            </a:r>
            <a:endParaRPr lang="en-US" sz="12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D788B83-892F-A38A-08CB-4BA61887074E}"/>
              </a:ext>
            </a:extLst>
          </p:cNvPr>
          <p:cNvSpPr txBox="1"/>
          <p:nvPr/>
        </p:nvSpPr>
        <p:spPr>
          <a:xfrm rot="16200000">
            <a:off x="3203895" y="1534970"/>
            <a:ext cx="626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DMSO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CC1FCD8-2FA3-692B-E070-112618F0F93E}"/>
              </a:ext>
            </a:extLst>
          </p:cNvPr>
          <p:cNvSpPr txBox="1"/>
          <p:nvPr/>
        </p:nvSpPr>
        <p:spPr>
          <a:xfrm rot="16200000">
            <a:off x="3540077" y="1534970"/>
            <a:ext cx="626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DMSO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1284172-85C5-DBAD-FF78-0212435B1A97}"/>
              </a:ext>
            </a:extLst>
          </p:cNvPr>
          <p:cNvSpPr txBox="1"/>
          <p:nvPr/>
        </p:nvSpPr>
        <p:spPr>
          <a:xfrm rot="16200000">
            <a:off x="3864843" y="1515245"/>
            <a:ext cx="6661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gefitnib</a:t>
            </a:r>
            <a:endParaRPr lang="en-US" sz="12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BC397FA-B487-8531-0348-1A0EB16F61A0}"/>
              </a:ext>
            </a:extLst>
          </p:cNvPr>
          <p:cNvSpPr txBox="1"/>
          <p:nvPr/>
        </p:nvSpPr>
        <p:spPr>
          <a:xfrm rot="16200000">
            <a:off x="4127219" y="1518514"/>
            <a:ext cx="6595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afatinib</a:t>
            </a:r>
            <a:endParaRPr lang="en-US" sz="12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30434C7-81A6-43CF-7401-02881E2173ED}"/>
              </a:ext>
            </a:extLst>
          </p:cNvPr>
          <p:cNvSpPr txBox="1"/>
          <p:nvPr/>
        </p:nvSpPr>
        <p:spPr>
          <a:xfrm rot="16200000">
            <a:off x="4259165" y="1379335"/>
            <a:ext cx="9379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osimertinib</a:t>
            </a:r>
            <a:endParaRPr lang="en-US" sz="12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E00DB71E-1E3B-09E1-3549-860569A56187}"/>
              </a:ext>
            </a:extLst>
          </p:cNvPr>
          <p:cNvSpPr txBox="1"/>
          <p:nvPr/>
        </p:nvSpPr>
        <p:spPr>
          <a:xfrm rot="16200000">
            <a:off x="4572699" y="1379335"/>
            <a:ext cx="9379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tarloxotinib</a:t>
            </a:r>
            <a:endParaRPr lang="en-US" sz="12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77334D80-7B4F-40CF-BB62-213E2B14910B}"/>
              </a:ext>
            </a:extLst>
          </p:cNvPr>
          <p:cNvSpPr txBox="1"/>
          <p:nvPr/>
        </p:nvSpPr>
        <p:spPr>
          <a:xfrm>
            <a:off x="2067812" y="830163"/>
            <a:ext cx="12460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00nM </a:t>
            </a:r>
            <a:r>
              <a:rPr lang="en-US" sz="1200" dirty="0" err="1"/>
              <a:t>alectinib</a:t>
            </a:r>
            <a:endParaRPr lang="en-US" sz="1200" dirty="0"/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002ED252-8C2D-D0C5-5FFD-401D8E93111C}"/>
              </a:ext>
            </a:extLst>
          </p:cNvPr>
          <p:cNvCxnSpPr/>
          <p:nvPr/>
        </p:nvCxnSpPr>
        <p:spPr>
          <a:xfrm>
            <a:off x="2044591" y="1086750"/>
            <a:ext cx="129591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5C82AE51-ADEE-5F1B-503A-89EE41A18328}"/>
              </a:ext>
            </a:extLst>
          </p:cNvPr>
          <p:cNvSpPr txBox="1"/>
          <p:nvPr/>
        </p:nvSpPr>
        <p:spPr>
          <a:xfrm>
            <a:off x="3836953" y="858817"/>
            <a:ext cx="12460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00nM </a:t>
            </a:r>
            <a:r>
              <a:rPr lang="en-US" sz="1200" dirty="0" err="1"/>
              <a:t>alectinib</a:t>
            </a:r>
            <a:endParaRPr lang="en-US" sz="1200" dirty="0"/>
          </a:p>
        </p:txBody>
      </p: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92A0E672-D0B1-301B-234B-719B2CEFADE2}"/>
              </a:ext>
            </a:extLst>
          </p:cNvPr>
          <p:cNvCxnSpPr/>
          <p:nvPr/>
        </p:nvCxnSpPr>
        <p:spPr>
          <a:xfrm>
            <a:off x="3813732" y="1115404"/>
            <a:ext cx="129591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62069AD0-7D7A-BF6B-4391-B19D303CF2F7}"/>
              </a:ext>
            </a:extLst>
          </p:cNvPr>
          <p:cNvCxnSpPr/>
          <p:nvPr/>
        </p:nvCxnSpPr>
        <p:spPr>
          <a:xfrm>
            <a:off x="7760660" y="587053"/>
            <a:ext cx="166163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9C66BDCA-7502-B237-6F0C-E72603A0486D}"/>
              </a:ext>
            </a:extLst>
          </p:cNvPr>
          <p:cNvCxnSpPr/>
          <p:nvPr/>
        </p:nvCxnSpPr>
        <p:spPr>
          <a:xfrm>
            <a:off x="9587376" y="587053"/>
            <a:ext cx="166163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id="{3D292BD5-3C11-1905-CBAC-6ACFBEB4B92D}"/>
              </a:ext>
            </a:extLst>
          </p:cNvPr>
          <p:cNvSpPr txBox="1"/>
          <p:nvPr/>
        </p:nvSpPr>
        <p:spPr>
          <a:xfrm rot="16200000">
            <a:off x="7493638" y="1393070"/>
            <a:ext cx="626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DMSO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44B7FBD7-C040-DE42-96FE-BF2A92EAD8F3}"/>
              </a:ext>
            </a:extLst>
          </p:cNvPr>
          <p:cNvSpPr txBox="1"/>
          <p:nvPr/>
        </p:nvSpPr>
        <p:spPr>
          <a:xfrm rot="16200000">
            <a:off x="7829820" y="1393070"/>
            <a:ext cx="626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DMSO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39BB9867-F435-4A9B-4D0A-C5D2E2A86276}"/>
              </a:ext>
            </a:extLst>
          </p:cNvPr>
          <p:cNvSpPr txBox="1"/>
          <p:nvPr/>
        </p:nvSpPr>
        <p:spPr>
          <a:xfrm rot="16200000">
            <a:off x="8154586" y="1373345"/>
            <a:ext cx="6661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gefitnib</a:t>
            </a:r>
            <a:endParaRPr lang="en-US" sz="1200" dirty="0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BE79AB9C-CC63-0EAE-74F9-50F005AB9CA7}"/>
              </a:ext>
            </a:extLst>
          </p:cNvPr>
          <p:cNvSpPr txBox="1"/>
          <p:nvPr/>
        </p:nvSpPr>
        <p:spPr>
          <a:xfrm rot="16200000">
            <a:off x="8416962" y="1376614"/>
            <a:ext cx="6595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afatinib</a:t>
            </a:r>
            <a:endParaRPr lang="en-US" sz="1200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8132B303-D311-912D-5C3A-E43D058A3DD7}"/>
              </a:ext>
            </a:extLst>
          </p:cNvPr>
          <p:cNvSpPr txBox="1"/>
          <p:nvPr/>
        </p:nvSpPr>
        <p:spPr>
          <a:xfrm rot="16200000">
            <a:off x="8548908" y="1237435"/>
            <a:ext cx="9379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osimertinib</a:t>
            </a:r>
            <a:endParaRPr lang="en-US" sz="1200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A6B6AED9-E83E-8914-9E1C-3B7FA3669FBC}"/>
              </a:ext>
            </a:extLst>
          </p:cNvPr>
          <p:cNvSpPr txBox="1"/>
          <p:nvPr/>
        </p:nvSpPr>
        <p:spPr>
          <a:xfrm rot="16200000">
            <a:off x="8862442" y="1237435"/>
            <a:ext cx="9379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tarloxotinib</a:t>
            </a:r>
            <a:endParaRPr lang="en-US" sz="1200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B7BC3BE0-E8D8-CA87-9FCE-45BDBAB110CD}"/>
              </a:ext>
            </a:extLst>
          </p:cNvPr>
          <p:cNvSpPr txBox="1"/>
          <p:nvPr/>
        </p:nvSpPr>
        <p:spPr>
          <a:xfrm rot="16200000">
            <a:off x="9302461" y="1410355"/>
            <a:ext cx="626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DMSO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6BCE7432-7A3A-CC6E-3C95-070514E1D878}"/>
              </a:ext>
            </a:extLst>
          </p:cNvPr>
          <p:cNvSpPr txBox="1"/>
          <p:nvPr/>
        </p:nvSpPr>
        <p:spPr>
          <a:xfrm rot="16200000">
            <a:off x="9638643" y="1410355"/>
            <a:ext cx="626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DMSO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931A7E87-273F-D853-2019-9599D816394E}"/>
              </a:ext>
            </a:extLst>
          </p:cNvPr>
          <p:cNvSpPr txBox="1"/>
          <p:nvPr/>
        </p:nvSpPr>
        <p:spPr>
          <a:xfrm rot="16200000">
            <a:off x="9963409" y="1390630"/>
            <a:ext cx="6661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gefitnib</a:t>
            </a:r>
            <a:endParaRPr lang="en-US" sz="1200" dirty="0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E425136C-9955-B34D-31B9-B1AD14A2798A}"/>
              </a:ext>
            </a:extLst>
          </p:cNvPr>
          <p:cNvSpPr txBox="1"/>
          <p:nvPr/>
        </p:nvSpPr>
        <p:spPr>
          <a:xfrm rot="16200000">
            <a:off x="10225785" y="1393899"/>
            <a:ext cx="6595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afatinib</a:t>
            </a:r>
            <a:endParaRPr lang="en-US" sz="1200" dirty="0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34E6044A-847C-3371-1845-33C7E111412E}"/>
              </a:ext>
            </a:extLst>
          </p:cNvPr>
          <p:cNvSpPr txBox="1"/>
          <p:nvPr/>
        </p:nvSpPr>
        <p:spPr>
          <a:xfrm rot="16200000">
            <a:off x="10357731" y="1254720"/>
            <a:ext cx="9379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osimertinib</a:t>
            </a:r>
            <a:endParaRPr lang="en-US" sz="1200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A505C432-5D05-C6AF-07B6-653B3F602DAE}"/>
              </a:ext>
            </a:extLst>
          </p:cNvPr>
          <p:cNvSpPr txBox="1"/>
          <p:nvPr/>
        </p:nvSpPr>
        <p:spPr>
          <a:xfrm rot="16200000">
            <a:off x="10671265" y="1254720"/>
            <a:ext cx="9379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tarloxotinib</a:t>
            </a:r>
            <a:endParaRPr lang="en-US" sz="1200" dirty="0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9A38220D-19A2-E9BF-7263-2C47D06E0BF6}"/>
              </a:ext>
            </a:extLst>
          </p:cNvPr>
          <p:cNvSpPr txBox="1"/>
          <p:nvPr/>
        </p:nvSpPr>
        <p:spPr>
          <a:xfrm>
            <a:off x="8166378" y="705548"/>
            <a:ext cx="12460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00nM </a:t>
            </a:r>
            <a:r>
              <a:rPr lang="en-US" sz="1200" dirty="0" err="1"/>
              <a:t>alectinib</a:t>
            </a:r>
            <a:endParaRPr lang="en-US" sz="1200" dirty="0"/>
          </a:p>
        </p:txBody>
      </p: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394AAE72-10BE-E1E5-ED0D-30E8C461F579}"/>
              </a:ext>
            </a:extLst>
          </p:cNvPr>
          <p:cNvCxnSpPr/>
          <p:nvPr/>
        </p:nvCxnSpPr>
        <p:spPr>
          <a:xfrm>
            <a:off x="8143157" y="962135"/>
            <a:ext cx="129591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66">
            <a:extLst>
              <a:ext uri="{FF2B5EF4-FFF2-40B4-BE49-F238E27FC236}">
                <a16:creationId xmlns:a16="http://schemas.microsoft.com/office/drawing/2014/main" id="{5EFA2D4A-09F8-F1B0-A4BD-3ECEC0A70042}"/>
              </a:ext>
            </a:extLst>
          </p:cNvPr>
          <p:cNvSpPr txBox="1"/>
          <p:nvPr/>
        </p:nvSpPr>
        <p:spPr>
          <a:xfrm>
            <a:off x="9935519" y="734202"/>
            <a:ext cx="12460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00nM </a:t>
            </a:r>
            <a:r>
              <a:rPr lang="en-US" sz="1200" dirty="0" err="1"/>
              <a:t>alectinib</a:t>
            </a:r>
            <a:endParaRPr lang="en-US" sz="1200" dirty="0"/>
          </a:p>
        </p:txBody>
      </p: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A54D0153-AD72-2850-A22A-981DEBBB6484}"/>
              </a:ext>
            </a:extLst>
          </p:cNvPr>
          <p:cNvCxnSpPr/>
          <p:nvPr/>
        </p:nvCxnSpPr>
        <p:spPr>
          <a:xfrm>
            <a:off x="9912298" y="990789"/>
            <a:ext cx="129591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68">
            <a:extLst>
              <a:ext uri="{FF2B5EF4-FFF2-40B4-BE49-F238E27FC236}">
                <a16:creationId xmlns:a16="http://schemas.microsoft.com/office/drawing/2014/main" id="{6A3A8123-05CE-3B5C-DF8A-C1A45EBB7545}"/>
              </a:ext>
            </a:extLst>
          </p:cNvPr>
          <p:cNvSpPr txBox="1"/>
          <p:nvPr/>
        </p:nvSpPr>
        <p:spPr>
          <a:xfrm>
            <a:off x="5830349" y="5144809"/>
            <a:ext cx="864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APDH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B1E0155C-A5A1-B5A9-9670-2BED2BF88EF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78601" y="1962150"/>
            <a:ext cx="4505325" cy="146685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5FFA6FB7-B703-090F-2E22-924CE4069D0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78600" y="3573183"/>
            <a:ext cx="4505325" cy="12573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FCA71FFD-3658-37CC-0892-15E0C077309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02216" y="1961133"/>
            <a:ext cx="4886325" cy="1504950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31CEA8D8-8BB5-1496-14D3-FF42EF09ABD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902216" y="3577511"/>
            <a:ext cx="4886325" cy="1200150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3D3F725F-112E-BD68-6D52-E9D12B3A8B8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902216" y="5067111"/>
            <a:ext cx="4886325" cy="800100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848E91D9-9F43-6FF0-5406-0EE767084DED}"/>
              </a:ext>
            </a:extLst>
          </p:cNvPr>
          <p:cNvSpPr txBox="1"/>
          <p:nvPr/>
        </p:nvSpPr>
        <p:spPr>
          <a:xfrm>
            <a:off x="7492875" y="206270"/>
            <a:ext cx="20569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RBB2-GRB7 (short)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4C119DE4-24CB-D179-207F-A9AD1047CB77}"/>
              </a:ext>
            </a:extLst>
          </p:cNvPr>
          <p:cNvSpPr txBox="1"/>
          <p:nvPr/>
        </p:nvSpPr>
        <p:spPr>
          <a:xfrm>
            <a:off x="9728803" y="206270"/>
            <a:ext cx="18469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RBB2-GR7 (long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6C28F04-C249-A6F3-9956-09EC0AA7BD77}"/>
              </a:ext>
            </a:extLst>
          </p:cNvPr>
          <p:cNvSpPr txBox="1"/>
          <p:nvPr/>
        </p:nvSpPr>
        <p:spPr>
          <a:xfrm>
            <a:off x="1763535" y="6297334"/>
            <a:ext cx="1330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00 channel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1BB09DF-47A3-2F8B-160F-8B9645AD4AE8}"/>
              </a:ext>
            </a:extLst>
          </p:cNvPr>
          <p:cNvSpPr txBox="1"/>
          <p:nvPr/>
        </p:nvSpPr>
        <p:spPr>
          <a:xfrm>
            <a:off x="8811892" y="6297334"/>
            <a:ext cx="1330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00 channel</a:t>
            </a:r>
          </a:p>
        </p:txBody>
      </p:sp>
    </p:spTree>
    <p:extLst>
      <p:ext uri="{BB962C8B-B14F-4D97-AF65-F5344CB8AC3E}">
        <p14:creationId xmlns:p14="http://schemas.microsoft.com/office/powerpoint/2010/main" val="1715979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3</TotalTime>
  <Words>106</Words>
  <Application>Microsoft Macintosh PowerPoint</Application>
  <PresentationFormat>Widescreen</PresentationFormat>
  <Paragraphs>8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, Anh</dc:creator>
  <cp:lastModifiedBy>Schubert, Laura</cp:lastModifiedBy>
  <cp:revision>6</cp:revision>
  <dcterms:created xsi:type="dcterms:W3CDTF">2022-12-18T00:04:37Z</dcterms:created>
  <dcterms:modified xsi:type="dcterms:W3CDTF">2023-01-05T17:35:13Z</dcterms:modified>
</cp:coreProperties>
</file>